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gif" ContentType="image/gif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9942513" cy="67611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"/>
          <p:cNvSpPr/>
          <p:nvPr/>
        </p:nvSpPr>
        <p:spPr>
          <a:xfrm>
            <a:off x="0" y="0"/>
            <a:ext cx="9943200" cy="676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2000" spc="-1" strike="noStrike">
              <a:solidFill>
                <a:srgbClr val="0000ff"/>
              </a:solidFill>
              <a:latin typeface="Arial"/>
            </a:endParaRPr>
          </a:p>
        </p:txBody>
      </p:sp>
      <p:sp>
        <p:nvSpPr>
          <p:cNvPr id="43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4308480" cy="338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000ff"/>
              </a:solidFill>
              <a:latin typeface="Arial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dt" idx="4"/>
          </p:nvPr>
        </p:nvSpPr>
        <p:spPr>
          <a:xfrm>
            <a:off x="5632560" y="-360"/>
            <a:ext cx="4308480" cy="338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000ff"/>
              </a:solidFill>
              <a:latin typeface="Arial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 type="sldImg"/>
          </p:nvPr>
        </p:nvSpPr>
        <p:spPr>
          <a:xfrm>
            <a:off x="3279600" y="506520"/>
            <a:ext cx="3383280" cy="253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4"/>
          <p:cNvSpPr>
            <a:spLocks noGrp="1"/>
          </p:cNvSpPr>
          <p:nvPr>
            <p:ph type="body"/>
          </p:nvPr>
        </p:nvSpPr>
        <p:spPr>
          <a:xfrm>
            <a:off x="993600" y="3211200"/>
            <a:ext cx="7955280" cy="30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5"/>
          <p:cNvSpPr>
            <a:spLocks noGrp="1"/>
          </p:cNvSpPr>
          <p:nvPr>
            <p:ph type="ftr" idx="5"/>
          </p:nvPr>
        </p:nvSpPr>
        <p:spPr>
          <a:xfrm>
            <a:off x="0" y="6421320"/>
            <a:ext cx="4308480" cy="338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000ff"/>
              </a:solidFill>
              <a:latin typeface="Arial"/>
            </a:endParaRPr>
          </a:p>
        </p:txBody>
      </p:sp>
      <p:sp>
        <p:nvSpPr>
          <p:cNvPr id="48" name="PlaceHolder 6"/>
          <p:cNvSpPr>
            <a:spLocks noGrp="1"/>
          </p:cNvSpPr>
          <p:nvPr>
            <p:ph type="sldNum" idx="6"/>
          </p:nvPr>
        </p:nvSpPr>
        <p:spPr>
          <a:xfrm>
            <a:off x="5632560" y="6421320"/>
            <a:ext cx="4308480" cy="338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7EC03D1-C2E4-4262-B811-0252D5A2C3A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sldImg"/>
          </p:nvPr>
        </p:nvSpPr>
        <p:spPr>
          <a:xfrm>
            <a:off x="3279600" y="506520"/>
            <a:ext cx="3383280" cy="2536560"/>
          </a:xfrm>
          <a:prstGeom prst="rect">
            <a:avLst/>
          </a:prstGeom>
          <a:ln w="0">
            <a:noFill/>
          </a:ln>
        </p:spPr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993600" y="3211200"/>
            <a:ext cx="7955280" cy="304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灯片编号占位符 3"/>
          <p:cNvSpPr/>
          <p:nvPr/>
        </p:nvSpPr>
        <p:spPr>
          <a:xfrm>
            <a:off x="5632560" y="6421320"/>
            <a:ext cx="4308480" cy="33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707C80-98AD-445C-B80B-4860C7AF4C5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ff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07D32D-023D-415C-895E-6DE9B7A00D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B24A5B-DB31-455A-A1F3-501F5A05C4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1FE5F0-BEB7-4BA4-83DF-5B0A302F80C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A6D64F-5679-4773-A0C9-AFB68E70FE8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CDD396-0D5F-4AF2-9790-FF77639E52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D01215-C157-42D3-8DE3-DF7921F3C5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0CA577-4301-44F4-B761-9E2D9A11D7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620FF9-5BFA-44A8-A4FD-59B417FB81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1372ED-9218-4658-B6FA-0D24F8F06D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A8DCA8-62AA-4828-936B-7B01208EAB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184313-0302-4667-AA35-FC6A73D5F8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E6CD83-0E78-4B44-8310-8371BE805D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898989"/>
                </a:solidFill>
                <a:latin typeface="Calibri"/>
              </a:rPr>
              <a:t>2014/9/17</a:t>
            </a:r>
            <a:endParaRPr b="1" lang="en-US" sz="1200" spc="-1" strike="noStrike">
              <a:solidFill>
                <a:srgbClr val="0000ff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000ff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099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zh-CN" sz="1800" spc="-1" strike="noStrike">
                <a:solidFill>
                  <a:srgbClr val="0000ff"/>
                </a:solidFill>
                <a:latin typeface="微软雅黑"/>
                <a:ea typeface="微软雅黑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0B42073-F5D6-48AE-B834-FA4FD6FBF225}" type="slidenum">
              <a:rPr b="1" lang="zh-CN" sz="1800" spc="-1" strike="noStrike">
                <a:solidFill>
                  <a:srgbClr val="0000ff"/>
                </a:solidFill>
                <a:latin typeface="微软雅黑"/>
                <a:ea typeface="微软雅黑"/>
              </a:rPr>
              <a:t>&lt;number&gt;</a:t>
            </a:fld>
            <a:endParaRPr b="1" lang="en-US" sz="1800" spc="-1" strike="noStrike">
              <a:solidFill>
                <a:srgbClr val="0000ff"/>
              </a:solidFill>
              <a:latin typeface="Arial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0" y="836640"/>
            <a:ext cx="9144000" cy="76320"/>
          </a:xfrm>
          <a:prstGeom prst="rect">
            <a:avLst/>
          </a:prstGeom>
          <a:gradFill rotWithShape="0">
            <a:gsLst>
              <a:gs pos="0">
                <a:srgbClr val="a603ab"/>
              </a:gs>
              <a:gs pos="100000">
                <a:srgbClr val="a603ab"/>
              </a:gs>
            </a:gsLst>
            <a:lin ang="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000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gif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标题 26"/>
          <p:cNvSpPr/>
          <p:nvPr/>
        </p:nvSpPr>
        <p:spPr>
          <a:xfrm>
            <a:off x="457200" y="115920"/>
            <a:ext cx="8229600" cy="71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 fontScale="92000"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Palatino Linotype"/>
                <a:ea typeface="华文中宋"/>
              </a:rPr>
              <a:t>Image processing of coded markers</a:t>
            </a:r>
            <a:endParaRPr b="1" lang="en-US" sz="3600" spc="-1" strike="noStrike">
              <a:solidFill>
                <a:srgbClr val="0000ff"/>
              </a:solidFill>
              <a:latin typeface="Arial"/>
            </a:endParaRPr>
          </a:p>
        </p:txBody>
      </p:sp>
      <p:pic>
        <p:nvPicPr>
          <p:cNvPr id="50" name="图片 6" descr=""/>
          <p:cNvPicPr/>
          <p:nvPr/>
        </p:nvPicPr>
        <p:blipFill>
          <a:blip r:embed="rId1"/>
          <a:stretch/>
        </p:blipFill>
        <p:spPr>
          <a:xfrm>
            <a:off x="2556000" y="1628640"/>
            <a:ext cx="4205160" cy="4230720"/>
          </a:xfrm>
          <a:prstGeom prst="rect">
            <a:avLst/>
          </a:prstGeom>
          <a:ln w="0">
            <a:noFill/>
          </a:ln>
          <a:effectLst>
            <a:outerShdw dist="153753" dir="2700000" blurRad="0" rotWithShape="0">
              <a:srgbClr val="000000">
                <a:alpha val="40000"/>
              </a:srgbClr>
            </a:outerShdw>
          </a:effectLst>
        </p:spPr>
      </p:pic>
      <p:sp>
        <p:nvSpPr>
          <p:cNvPr id="51" name="矩形 1"/>
          <p:cNvSpPr/>
          <p:nvPr/>
        </p:nvSpPr>
        <p:spPr>
          <a:xfrm>
            <a:off x="539640" y="6093000"/>
            <a:ext cx="727236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f6266"/>
                </a:solidFill>
                <a:latin typeface="Palatino Linotype"/>
              </a:rPr>
              <a:t>Please click the slide show button to see the GIF animation  </a:t>
            </a:r>
            <a:r>
              <a:rPr b="0" lang="zh-CN" sz="2000" spc="-1" strike="noStrike">
                <a:solidFill>
                  <a:srgbClr val="5f6266"/>
                </a:solidFill>
                <a:latin typeface="Palatino Linotype"/>
              </a:rPr>
              <a:t>→</a:t>
            </a:r>
            <a:endParaRPr b="1" lang="en-US" sz="2000" spc="-1" strike="noStrike">
              <a:solidFill>
                <a:srgbClr val="0000ff"/>
              </a:solidFill>
              <a:latin typeface="Arial"/>
            </a:endParaRPr>
          </a:p>
        </p:txBody>
      </p:sp>
      <p:pic>
        <p:nvPicPr>
          <p:cNvPr id="52" name="图片 2" descr=""/>
          <p:cNvPicPr/>
          <p:nvPr/>
        </p:nvPicPr>
        <p:blipFill>
          <a:blip r:embed="rId2"/>
          <a:stretch/>
        </p:blipFill>
        <p:spPr>
          <a:xfrm>
            <a:off x="7740720" y="6113520"/>
            <a:ext cx="366480" cy="314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5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10-13T02:10:30Z</dcterms:created>
  <dc:creator>赵凯</dc:creator>
  <dc:description/>
  <dc:language>en-US</dc:language>
  <cp:lastModifiedBy>user</cp:lastModifiedBy>
  <cp:lastPrinted>2014-11-13T14:25:22Z</cp:lastPrinted>
  <dcterms:modified xsi:type="dcterms:W3CDTF">2019-01-25T07:18:49Z</dcterms:modified>
  <cp:revision>2637</cp:revision>
  <dc:subject/>
  <dc:title>加工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9.1.0.5132</vt:lpwstr>
  </property>
</Properties>
</file>